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90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5603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2858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3124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8164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953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5740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245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3058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2746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7891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3845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7F34E-6470-45F6-899E-41254D378EA3}" type="datetimeFigureOut">
              <a:rPr lang="fr-FR" smtClean="0"/>
              <a:t>05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39C5A-4798-4C19-AB99-C8BF99151C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8593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694"/>
          <a:stretch/>
        </p:blipFill>
        <p:spPr>
          <a:xfrm>
            <a:off x="8090910" y="501430"/>
            <a:ext cx="3535033" cy="4003167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220"/>
          <a:stretch/>
        </p:blipFill>
        <p:spPr>
          <a:xfrm>
            <a:off x="4087744" y="501431"/>
            <a:ext cx="3554028" cy="4003167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017"/>
          <a:stretch/>
        </p:blipFill>
        <p:spPr>
          <a:xfrm>
            <a:off x="84577" y="501429"/>
            <a:ext cx="3562138" cy="4003167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92116" y="4895840"/>
            <a:ext cx="991253" cy="509022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60158" y="4917612"/>
            <a:ext cx="696556" cy="509022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>
            <a:off x="4583369" y="4917612"/>
            <a:ext cx="1643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othermia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7664025" y="4869991"/>
            <a:ext cx="3711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ed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nagement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1382969" y="224428"/>
            <a:ext cx="1643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 A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5552198" y="213546"/>
            <a:ext cx="1643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 B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9593222" y="213546"/>
            <a:ext cx="1643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 C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773368" y="5657604"/>
            <a:ext cx="916528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pact of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nagement versus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othermia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first 68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ur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ndomization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	Panel A: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fr-FR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 B: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terial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essure</a:t>
            </a:r>
          </a:p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 C: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diac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equency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84895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46</Words>
  <Application>Microsoft Office PowerPoint</Application>
  <PresentationFormat>Grand écran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TIT Matthieu</dc:creator>
  <cp:lastModifiedBy>PETIT Matthieu</cp:lastModifiedBy>
  <cp:revision>3</cp:revision>
  <dcterms:created xsi:type="dcterms:W3CDTF">2022-01-05T09:00:32Z</dcterms:created>
  <dcterms:modified xsi:type="dcterms:W3CDTF">2022-01-05T09:17:50Z</dcterms:modified>
</cp:coreProperties>
</file>